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0" d="100"/>
          <a:sy n="80" d="100"/>
        </p:scale>
        <p:origin x="782" y="6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688304-7AEE-4886-952B-7AD6F01F2F5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A945664-6A7E-429E-9C28-35D7AC0D0B6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F1D4AC7-DCEE-4AE9-9EAD-17F9C0F21644}"/>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5" name="Footer Placeholder 4">
            <a:extLst>
              <a:ext uri="{FF2B5EF4-FFF2-40B4-BE49-F238E27FC236}">
                <a16:creationId xmlns:a16="http://schemas.microsoft.com/office/drawing/2014/main" id="{4C8BE197-DF1F-4227-B38B-9AE5CBD3184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848B6EE-1584-48FF-86B4-BCB8B734C1A3}"/>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7665523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5DD35D-D1BF-479E-BC1F-6E2CA66E7E1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9F559BB-68D1-46C9-853D-DCF698B4602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1C91123-B253-4752-A264-7E96147756B6}"/>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5" name="Footer Placeholder 4">
            <a:extLst>
              <a:ext uri="{FF2B5EF4-FFF2-40B4-BE49-F238E27FC236}">
                <a16:creationId xmlns:a16="http://schemas.microsoft.com/office/drawing/2014/main" id="{4A018086-2D83-4F98-BCA7-2F1C279D464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39FA1EE-B30B-48F4-8006-EA49821ECDC5}"/>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37035788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FFF1CFB-1377-4160-B6B5-7747FCDDD36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45E02CB-F290-46BB-A8F0-5F6A8F51FF0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9681100-BE9D-47BA-AA3C-114487B030CA}"/>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5" name="Footer Placeholder 4">
            <a:extLst>
              <a:ext uri="{FF2B5EF4-FFF2-40B4-BE49-F238E27FC236}">
                <a16:creationId xmlns:a16="http://schemas.microsoft.com/office/drawing/2014/main" id="{81E8DFAD-FD6C-4EC8-9463-60F21DE46F7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4A4A6F2-134C-4EC0-A1CB-395CAE7ACBF2}"/>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877095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C864A5-04B2-4700-BFD9-95E1A727531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DBBDC47-F75C-4780-BBFC-B0EC2FD3900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C77643D-11E3-4368-981E-1430D6399EEC}"/>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5" name="Footer Placeholder 4">
            <a:extLst>
              <a:ext uri="{FF2B5EF4-FFF2-40B4-BE49-F238E27FC236}">
                <a16:creationId xmlns:a16="http://schemas.microsoft.com/office/drawing/2014/main" id="{4BC3BD60-05DC-4C36-AF86-8A1AE485CE9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A107656-5F27-43EE-9A91-79D5C53A984E}"/>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7522465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5F89D7-CC4B-4D3E-90E6-399545F125C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6621E4C-302B-40E8-9D4E-F651DD3A327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847FA29-017B-47CA-856B-B172A47695D2}"/>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5" name="Footer Placeholder 4">
            <a:extLst>
              <a:ext uri="{FF2B5EF4-FFF2-40B4-BE49-F238E27FC236}">
                <a16:creationId xmlns:a16="http://schemas.microsoft.com/office/drawing/2014/main" id="{3DFB1647-F111-4ABC-AC39-4195411C0B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22ACAB-C540-42BA-8707-EF16C5BB1B41}"/>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840671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8CCA94-3916-4185-8B0C-4E847EA9EFC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3D6F374-3D0D-44E2-B554-C9F53CAC1D1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40B049F-F991-4CC1-AC46-BDFDF3C348F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02F5B5B-1D91-4D47-96E0-B027B465E8AC}"/>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6" name="Footer Placeholder 5">
            <a:extLst>
              <a:ext uri="{FF2B5EF4-FFF2-40B4-BE49-F238E27FC236}">
                <a16:creationId xmlns:a16="http://schemas.microsoft.com/office/drawing/2014/main" id="{727E7A54-1DF6-4E3A-B9E7-6D7385219FF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B92F8CE-448A-4A84-B738-17934ACE40B9}"/>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36404309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6756C7-4B69-4DF0-992B-F16381D0A4A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8C71405-5686-4D7A-9CEE-341A60FDC31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2742134-18EF-46ED-908A-D9FAF565449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114FF02-2CF4-4C7B-A7AB-788FA15ADA2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F468861-DE3F-4168-B840-6762A01DCB3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8EEF713-3BB8-425E-8F82-057F33231963}"/>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8" name="Footer Placeholder 7">
            <a:extLst>
              <a:ext uri="{FF2B5EF4-FFF2-40B4-BE49-F238E27FC236}">
                <a16:creationId xmlns:a16="http://schemas.microsoft.com/office/drawing/2014/main" id="{0E27CD4D-1C55-498C-B76E-B229EBFA1D0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CD244DE-752A-4711-8480-6E06E02603A1}"/>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15773942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7D6AAE-C65C-40DF-ABAF-A2683EC6D1D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59BF129-7152-4D00-B65E-F32BA505D26E}"/>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4" name="Footer Placeholder 3">
            <a:extLst>
              <a:ext uri="{FF2B5EF4-FFF2-40B4-BE49-F238E27FC236}">
                <a16:creationId xmlns:a16="http://schemas.microsoft.com/office/drawing/2014/main" id="{CD8D9FF9-4C17-4335-9E88-F85E0885AE2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19593D0-95D7-4506-8A4E-A51AFD3CF24F}"/>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16605791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B853834-66D2-4666-9029-F560B2437FD1}"/>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3" name="Footer Placeholder 2">
            <a:extLst>
              <a:ext uri="{FF2B5EF4-FFF2-40B4-BE49-F238E27FC236}">
                <a16:creationId xmlns:a16="http://schemas.microsoft.com/office/drawing/2014/main" id="{C06AE9D7-ADBF-408F-9836-E6009EA3D9D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DE76955-CA39-426F-8214-28EDE909F7D1}"/>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29736838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16D5B8-BC61-4028-8372-F333F3C79B5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602940C-E1EE-41CD-9F0E-BB047E33E2A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F1108DA-E1AE-41A7-8C4A-4AF0BB39012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D56E449-829B-4808-922C-CF4F71C58B41}"/>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6" name="Footer Placeholder 5">
            <a:extLst>
              <a:ext uri="{FF2B5EF4-FFF2-40B4-BE49-F238E27FC236}">
                <a16:creationId xmlns:a16="http://schemas.microsoft.com/office/drawing/2014/main" id="{279052AE-3AB6-4FCF-A2FB-F6BCA06CEEC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1E030D8-300C-4F8D-8306-30C68A94DADD}"/>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11457924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9C5363-A5F4-405D-84FE-46869929A0D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6231BB9-663D-42DD-AF10-400AC19B583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8243C46-E9C1-4CD4-AA03-9ACC6475CE8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2262D5E-98B7-4071-BFCF-6EC8D35FD54D}"/>
              </a:ext>
            </a:extLst>
          </p:cNvPr>
          <p:cNvSpPr>
            <a:spLocks noGrp="1"/>
          </p:cNvSpPr>
          <p:nvPr>
            <p:ph type="dt" sz="half" idx="10"/>
          </p:nvPr>
        </p:nvSpPr>
        <p:spPr/>
        <p:txBody>
          <a:bodyPr/>
          <a:lstStyle/>
          <a:p>
            <a:fld id="{A286C412-CC98-48A5-B55A-E216D41E2E9F}" type="datetimeFigureOut">
              <a:rPr lang="en-US" smtClean="0"/>
              <a:t>10/19/2020</a:t>
            </a:fld>
            <a:endParaRPr lang="en-US"/>
          </a:p>
        </p:txBody>
      </p:sp>
      <p:sp>
        <p:nvSpPr>
          <p:cNvPr id="6" name="Footer Placeholder 5">
            <a:extLst>
              <a:ext uri="{FF2B5EF4-FFF2-40B4-BE49-F238E27FC236}">
                <a16:creationId xmlns:a16="http://schemas.microsoft.com/office/drawing/2014/main" id="{8830FC37-2F58-4FA8-AF2B-D69B0B53161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3125965-8166-4572-BD6D-4E59D8962812}"/>
              </a:ext>
            </a:extLst>
          </p:cNvPr>
          <p:cNvSpPr>
            <a:spLocks noGrp="1"/>
          </p:cNvSpPr>
          <p:nvPr>
            <p:ph type="sldNum" sz="quarter" idx="12"/>
          </p:nvPr>
        </p:nvSpPr>
        <p:spPr/>
        <p:txBody>
          <a:bodyPr/>
          <a:lstStyle/>
          <a:p>
            <a:fld id="{D81A5297-2D27-4ACC-B532-7714DDF2C229}" type="slidenum">
              <a:rPr lang="en-US" smtClean="0"/>
              <a:t>‹#›</a:t>
            </a:fld>
            <a:endParaRPr lang="en-US"/>
          </a:p>
        </p:txBody>
      </p:sp>
    </p:spTree>
    <p:extLst>
      <p:ext uri="{BB962C8B-B14F-4D97-AF65-F5344CB8AC3E}">
        <p14:creationId xmlns:p14="http://schemas.microsoft.com/office/powerpoint/2010/main" val="29537769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52EC916-E01C-4F30-B0C2-7141412EF58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09EDEC8-B1E4-4DF1-971B-B3E30B465EA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3A4D3CA-5960-4289-BADC-612F1A130D8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286C412-CC98-48A5-B55A-E216D41E2E9F}" type="datetimeFigureOut">
              <a:rPr lang="en-US" smtClean="0"/>
              <a:t>10/19/2020</a:t>
            </a:fld>
            <a:endParaRPr lang="en-US"/>
          </a:p>
        </p:txBody>
      </p:sp>
      <p:sp>
        <p:nvSpPr>
          <p:cNvPr id="5" name="Footer Placeholder 4">
            <a:extLst>
              <a:ext uri="{FF2B5EF4-FFF2-40B4-BE49-F238E27FC236}">
                <a16:creationId xmlns:a16="http://schemas.microsoft.com/office/drawing/2014/main" id="{ED2796A2-B9DC-4C8C-82BC-225DB692BF9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847A2AC-8ECE-44D6-9861-46E2C96352F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81A5297-2D27-4ACC-B532-7714DDF2C229}" type="slidenum">
              <a:rPr lang="en-US" smtClean="0"/>
              <a:t>‹#›</a:t>
            </a:fld>
            <a:endParaRPr lang="en-US"/>
          </a:p>
        </p:txBody>
      </p:sp>
    </p:spTree>
    <p:extLst>
      <p:ext uri="{BB962C8B-B14F-4D97-AF65-F5344CB8AC3E}">
        <p14:creationId xmlns:p14="http://schemas.microsoft.com/office/powerpoint/2010/main" val="6251880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E4E3C03-80EB-4768-A14E-4244E10D91DA}"/>
              </a:ext>
            </a:extLst>
          </p:cNvPr>
          <p:cNvSpPr txBox="1"/>
          <p:nvPr/>
        </p:nvSpPr>
        <p:spPr>
          <a:xfrm>
            <a:off x="672499" y="4897964"/>
            <a:ext cx="10025814" cy="1754326"/>
          </a:xfrm>
          <a:prstGeom prst="rect">
            <a:avLst/>
          </a:prstGeom>
          <a:noFill/>
        </p:spPr>
        <p:txBody>
          <a:bodyPr wrap="square" rtlCol="0">
            <a:spAutoFit/>
          </a:bodyPr>
          <a:lstStyle/>
          <a:p>
            <a:r>
              <a:rPr lang="en-US" b="1" dirty="0"/>
              <a:t>Supplemental Figure 1. Gating Strategy for Th cell subset staining within the spleen. </a:t>
            </a:r>
            <a:r>
              <a:rPr lang="en-US" dirty="0"/>
              <a:t>Cells were gated using forward scatter height by forward scatter area to first gate singlets. Cells were then gated for side scatter area by forward scatter area to identify an immune cell bubble. Cells were then gated for being CD3+ in order to identify lymphocytes present. Lymphocyte subsets were then gated on CD4 by CD8 positivity to identify T helper and cytotoxic T cells. CD4+ T cells were then gated using histograms to identify Foxp3+ and ROR</a:t>
            </a:r>
            <a:r>
              <a:rPr lang="el-GR" dirty="0"/>
              <a:t>γ</a:t>
            </a:r>
            <a:r>
              <a:rPr lang="en-US" dirty="0"/>
              <a:t>T+ positivity amongst the CD4+ T cells. </a:t>
            </a:r>
            <a:endParaRPr lang="en-US" b="1" dirty="0"/>
          </a:p>
        </p:txBody>
      </p:sp>
      <p:pic>
        <p:nvPicPr>
          <p:cNvPr id="2" name="Picture 1">
            <a:extLst>
              <a:ext uri="{FF2B5EF4-FFF2-40B4-BE49-F238E27FC236}">
                <a16:creationId xmlns:a16="http://schemas.microsoft.com/office/drawing/2014/main" id="{937501B7-BA09-4B74-87C1-8F156CC3B66F}"/>
              </a:ext>
            </a:extLst>
          </p:cNvPr>
          <p:cNvPicPr>
            <a:picLocks noChangeAspect="1"/>
          </p:cNvPicPr>
          <p:nvPr/>
        </p:nvPicPr>
        <p:blipFill>
          <a:blip r:embed="rId2"/>
          <a:stretch>
            <a:fillRect/>
          </a:stretch>
        </p:blipFill>
        <p:spPr>
          <a:xfrm>
            <a:off x="167126" y="1452270"/>
            <a:ext cx="11857748" cy="2353260"/>
          </a:xfrm>
          <a:prstGeom prst="rect">
            <a:avLst/>
          </a:prstGeom>
        </p:spPr>
      </p:pic>
    </p:spTree>
    <p:extLst>
      <p:ext uri="{BB962C8B-B14F-4D97-AF65-F5344CB8AC3E}">
        <p14:creationId xmlns:p14="http://schemas.microsoft.com/office/powerpoint/2010/main" val="38964013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17E59056-4EE4-4378-A286-197601E1704E}"/>
              </a:ext>
            </a:extLst>
          </p:cNvPr>
          <p:cNvSpPr txBox="1"/>
          <p:nvPr/>
        </p:nvSpPr>
        <p:spPr>
          <a:xfrm>
            <a:off x="529892" y="5211177"/>
            <a:ext cx="10025814" cy="1477328"/>
          </a:xfrm>
          <a:prstGeom prst="rect">
            <a:avLst/>
          </a:prstGeom>
          <a:noFill/>
        </p:spPr>
        <p:txBody>
          <a:bodyPr wrap="square" rtlCol="0">
            <a:spAutoFit/>
          </a:bodyPr>
          <a:lstStyle/>
          <a:p>
            <a:r>
              <a:rPr lang="en-US" b="1" dirty="0"/>
              <a:t>Supplemental Figure 2. Gating Strategy for CD4+ T cell staining within the CNS. </a:t>
            </a:r>
            <a:r>
              <a:rPr lang="en-US" dirty="0"/>
              <a:t>Cells were gated using forward scatter height by forward scatter area to first gate singlets. Cells were then gated for side scatter area by forward scatter area to identify an immune cell bubble. Cells were then gated on side scatter area by CD45 expression to further remove debris and focus on immune cells. CD45+ cells were then gated for CD3 and CD4 positivity to identify CD4+ T cells. </a:t>
            </a:r>
          </a:p>
        </p:txBody>
      </p:sp>
      <p:pic>
        <p:nvPicPr>
          <p:cNvPr id="2" name="Picture 1">
            <a:extLst>
              <a:ext uri="{FF2B5EF4-FFF2-40B4-BE49-F238E27FC236}">
                <a16:creationId xmlns:a16="http://schemas.microsoft.com/office/drawing/2014/main" id="{2F3C7F2C-284A-4925-81D8-1F7FB3E14985}"/>
              </a:ext>
            </a:extLst>
          </p:cNvPr>
          <p:cNvPicPr>
            <a:picLocks noChangeAspect="1"/>
          </p:cNvPicPr>
          <p:nvPr/>
        </p:nvPicPr>
        <p:blipFill>
          <a:blip r:embed="rId2"/>
          <a:stretch>
            <a:fillRect/>
          </a:stretch>
        </p:blipFill>
        <p:spPr>
          <a:xfrm>
            <a:off x="188464" y="1385955"/>
            <a:ext cx="11815072" cy="2828789"/>
          </a:xfrm>
          <a:prstGeom prst="rect">
            <a:avLst/>
          </a:prstGeom>
        </p:spPr>
      </p:pic>
    </p:spTree>
    <p:extLst>
      <p:ext uri="{BB962C8B-B14F-4D97-AF65-F5344CB8AC3E}">
        <p14:creationId xmlns:p14="http://schemas.microsoft.com/office/powerpoint/2010/main" val="40269617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TotalTime>
  <Words>200</Words>
  <Application>Microsoft Office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OPKINS, NICHOLAS</dc:creator>
  <cp:lastModifiedBy>DOPKINS, NICHOLAS</cp:lastModifiedBy>
  <cp:revision>8</cp:revision>
  <dcterms:created xsi:type="dcterms:W3CDTF">2020-10-19T20:18:37Z</dcterms:created>
  <dcterms:modified xsi:type="dcterms:W3CDTF">2020-10-19T20:45:43Z</dcterms:modified>
</cp:coreProperties>
</file>